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1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9B400"/>
    <a:srgbClr val="A6A6A6"/>
    <a:srgbClr val="7F7F7F"/>
    <a:srgbClr val="555555"/>
    <a:srgbClr val="05E800"/>
    <a:srgbClr val="1A65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854" autoAdjust="0"/>
    <p:restoredTop sz="97717" autoAdjust="0"/>
  </p:normalViewPr>
  <p:slideViewPr>
    <p:cSldViewPr snapToGrid="0" snapToObjects="1">
      <p:cViewPr>
        <p:scale>
          <a:sx n="200" d="100"/>
          <a:sy n="200" d="100"/>
        </p:scale>
        <p:origin x="-80" y="48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file://localhost//Users/adelinemergoud/Desktop/papier%20/fichier%20figure/fig%201S/S1D-%20feuil%203-pool%20serie%201,%202%20et%203%20pour%20souche%20N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063709691692483"/>
          <c:y val="0.0381918926315093"/>
          <c:w val="0.654921004580568"/>
          <c:h val="0.7099828888292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uil3!$B$25</c:f>
              <c:strCache>
                <c:ptCount val="1"/>
                <c:pt idx="0">
                  <c:v>YA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3!$D$26:$D$43</c:f>
                <c:numCache>
                  <c:formatCode>General</c:formatCode>
                  <c:ptCount val="18"/>
                  <c:pt idx="0">
                    <c:v>0.286950567362768</c:v>
                  </c:pt>
                  <c:pt idx="1">
                    <c:v>0.356208253595433</c:v>
                  </c:pt>
                  <c:pt idx="2">
                    <c:v>0.352403749680856</c:v>
                  </c:pt>
                  <c:pt idx="3">
                    <c:v>0.3484014427782</c:v>
                  </c:pt>
                  <c:pt idx="4">
                    <c:v>0.309752098626874</c:v>
                  </c:pt>
                  <c:pt idx="5">
                    <c:v>0.347278051935566</c:v>
                  </c:pt>
                  <c:pt idx="6">
                    <c:v>0.30796800495977</c:v>
                  </c:pt>
                  <c:pt idx="7">
                    <c:v>0.350770578750686</c:v>
                  </c:pt>
                  <c:pt idx="8">
                    <c:v>0.345674465577912</c:v>
                  </c:pt>
                  <c:pt idx="9">
                    <c:v>0.302863117230054</c:v>
                  </c:pt>
                  <c:pt idx="10">
                    <c:v>0.328362375248377</c:v>
                  </c:pt>
                  <c:pt idx="11">
                    <c:v>0.343255207144429</c:v>
                  </c:pt>
                  <c:pt idx="12">
                    <c:v>0.279762986213126</c:v>
                  </c:pt>
                  <c:pt idx="13">
                    <c:v>0.15915359753773</c:v>
                  </c:pt>
                  <c:pt idx="14">
                    <c:v>0.193632029921759</c:v>
                  </c:pt>
                  <c:pt idx="15">
                    <c:v>0.164668724797254</c:v>
                  </c:pt>
                  <c:pt idx="16">
                    <c:v>0.400603278638813</c:v>
                  </c:pt>
                  <c:pt idx="17">
                    <c:v>0.386562047721656</c:v>
                  </c:pt>
                </c:numCache>
              </c:numRef>
            </c:plus>
            <c:minus>
              <c:numRef>
                <c:f>Feuil3!$D$26:$D$43</c:f>
                <c:numCache>
                  <c:formatCode>General</c:formatCode>
                  <c:ptCount val="18"/>
                  <c:pt idx="0">
                    <c:v>0.286950567362768</c:v>
                  </c:pt>
                  <c:pt idx="1">
                    <c:v>0.356208253595433</c:v>
                  </c:pt>
                  <c:pt idx="2">
                    <c:v>0.352403749680856</c:v>
                  </c:pt>
                  <c:pt idx="3">
                    <c:v>0.3484014427782</c:v>
                  </c:pt>
                  <c:pt idx="4">
                    <c:v>0.309752098626874</c:v>
                  </c:pt>
                  <c:pt idx="5">
                    <c:v>0.347278051935566</c:v>
                  </c:pt>
                  <c:pt idx="6">
                    <c:v>0.30796800495977</c:v>
                  </c:pt>
                  <c:pt idx="7">
                    <c:v>0.350770578750686</c:v>
                  </c:pt>
                  <c:pt idx="8">
                    <c:v>0.345674465577912</c:v>
                  </c:pt>
                  <c:pt idx="9">
                    <c:v>0.302863117230054</c:v>
                  </c:pt>
                  <c:pt idx="10">
                    <c:v>0.328362375248377</c:v>
                  </c:pt>
                  <c:pt idx="11">
                    <c:v>0.343255207144429</c:v>
                  </c:pt>
                  <c:pt idx="12">
                    <c:v>0.279762986213126</c:v>
                  </c:pt>
                  <c:pt idx="13">
                    <c:v>0.15915359753773</c:v>
                  </c:pt>
                  <c:pt idx="14">
                    <c:v>0.193632029921759</c:v>
                  </c:pt>
                  <c:pt idx="15">
                    <c:v>0.164668724797254</c:v>
                  </c:pt>
                  <c:pt idx="16">
                    <c:v>0.400603278638813</c:v>
                  </c:pt>
                  <c:pt idx="17">
                    <c:v>0.386562047721656</c:v>
                  </c:pt>
                </c:numCache>
              </c:numRef>
            </c:minus>
          </c:errBars>
          <c:cat>
            <c:strRef>
              <c:f>Feuil3!$A$26:$A$41</c:f>
              <c:strCache>
                <c:ptCount val="16"/>
                <c:pt idx="0">
                  <c:v>tnt-2</c:v>
                </c:pt>
                <c:pt idx="1">
                  <c:v>mlc-3</c:v>
                </c:pt>
                <c:pt idx="2">
                  <c:v>unc-54</c:v>
                </c:pt>
                <c:pt idx="3">
                  <c:v>mlc-1</c:v>
                </c:pt>
                <c:pt idx="4">
                  <c:v>mlc-2</c:v>
                </c:pt>
                <c:pt idx="5">
                  <c:v>unc-27</c:v>
                </c:pt>
                <c:pt idx="6">
                  <c:v>unc-15</c:v>
                </c:pt>
                <c:pt idx="7">
                  <c:v>M02D8.1</c:v>
                </c:pt>
                <c:pt idx="8">
                  <c:v>csq-1</c:v>
                </c:pt>
                <c:pt idx="9">
                  <c:v>mup-2</c:v>
                </c:pt>
                <c:pt idx="10">
                  <c:v>unc-87</c:v>
                </c:pt>
                <c:pt idx="11">
                  <c:v>twk-18</c:v>
                </c:pt>
                <c:pt idx="12">
                  <c:v>alp-1</c:v>
                </c:pt>
                <c:pt idx="13">
                  <c:v>mig-17</c:v>
                </c:pt>
                <c:pt idx="14">
                  <c:v>F21H7.3</c:v>
                </c:pt>
                <c:pt idx="15">
                  <c:v>dys-1</c:v>
                </c:pt>
              </c:strCache>
            </c:strRef>
          </c:cat>
          <c:val>
            <c:numRef>
              <c:f>Feuil3!$B$26:$B$41</c:f>
              <c:numCache>
                <c:formatCode>General</c:formatCode>
                <c:ptCount val="16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  <c:pt idx="7">
                  <c:v>1.0</c:v>
                </c:pt>
                <c:pt idx="8">
                  <c:v>1.0</c:v>
                </c:pt>
                <c:pt idx="9">
                  <c:v>1.0</c:v>
                </c:pt>
                <c:pt idx="10">
                  <c:v>1.0</c:v>
                </c:pt>
                <c:pt idx="11">
                  <c:v>1.0</c:v>
                </c:pt>
                <c:pt idx="12">
                  <c:v>1.0</c:v>
                </c:pt>
                <c:pt idx="13">
                  <c:v>1.0</c:v>
                </c:pt>
                <c:pt idx="14">
                  <c:v>1.0</c:v>
                </c:pt>
                <c:pt idx="15">
                  <c:v>1.0</c:v>
                </c:pt>
              </c:numCache>
            </c:numRef>
          </c:val>
        </c:ser>
        <c:ser>
          <c:idx val="1"/>
          <c:order val="1"/>
          <c:tx>
            <c:strRef>
              <c:f>Feuil3!$C$25</c:f>
              <c:strCache>
                <c:ptCount val="1"/>
                <c:pt idx="0">
                  <c:v> day 7 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3!$E$26:$E$43</c:f>
                <c:numCache>
                  <c:formatCode>General</c:formatCode>
                  <c:ptCount val="18"/>
                  <c:pt idx="0">
                    <c:v>0.00387857027208579</c:v>
                  </c:pt>
                  <c:pt idx="1">
                    <c:v>0.00622800442771283</c:v>
                  </c:pt>
                  <c:pt idx="2">
                    <c:v>0.00398202742021622</c:v>
                  </c:pt>
                  <c:pt idx="3">
                    <c:v>0.0123678386860427</c:v>
                  </c:pt>
                  <c:pt idx="4">
                    <c:v>0.00814698028663115</c:v>
                  </c:pt>
                  <c:pt idx="5">
                    <c:v>0.0101204446061404</c:v>
                  </c:pt>
                  <c:pt idx="6">
                    <c:v>0.00946214684381736</c:v>
                  </c:pt>
                  <c:pt idx="7">
                    <c:v>0.0124500092705331</c:v>
                  </c:pt>
                  <c:pt idx="8">
                    <c:v>0.0121699084382536</c:v>
                  </c:pt>
                  <c:pt idx="9">
                    <c:v>0.00959153128649172</c:v>
                  </c:pt>
                  <c:pt idx="10">
                    <c:v>0.0163348483300817</c:v>
                  </c:pt>
                  <c:pt idx="11">
                    <c:v>0.0393758804826721</c:v>
                  </c:pt>
                  <c:pt idx="12">
                    <c:v>0.0146253333024438</c:v>
                  </c:pt>
                  <c:pt idx="13">
                    <c:v>0.15862952326932</c:v>
                  </c:pt>
                  <c:pt idx="14">
                    <c:v>0.412128797121843</c:v>
                  </c:pt>
                  <c:pt idx="15">
                    <c:v>0.0656513399975749</c:v>
                  </c:pt>
                  <c:pt idx="16">
                    <c:v>0.153308949546769</c:v>
                  </c:pt>
                  <c:pt idx="17">
                    <c:v>0.927894706445102</c:v>
                  </c:pt>
                </c:numCache>
              </c:numRef>
            </c:plus>
            <c:minus>
              <c:numRef>
                <c:f>Feuil3!$E$26:$E$43</c:f>
                <c:numCache>
                  <c:formatCode>General</c:formatCode>
                  <c:ptCount val="18"/>
                  <c:pt idx="0">
                    <c:v>0.00387857027208579</c:v>
                  </c:pt>
                  <c:pt idx="1">
                    <c:v>0.00622800442771283</c:v>
                  </c:pt>
                  <c:pt idx="2">
                    <c:v>0.00398202742021622</c:v>
                  </c:pt>
                  <c:pt idx="3">
                    <c:v>0.0123678386860427</c:v>
                  </c:pt>
                  <c:pt idx="4">
                    <c:v>0.00814698028663115</c:v>
                  </c:pt>
                  <c:pt idx="5">
                    <c:v>0.0101204446061404</c:v>
                  </c:pt>
                  <c:pt idx="6">
                    <c:v>0.00946214684381736</c:v>
                  </c:pt>
                  <c:pt idx="7">
                    <c:v>0.0124500092705331</c:v>
                  </c:pt>
                  <c:pt idx="8">
                    <c:v>0.0121699084382536</c:v>
                  </c:pt>
                  <c:pt idx="9">
                    <c:v>0.00959153128649172</c:v>
                  </c:pt>
                  <c:pt idx="10">
                    <c:v>0.0163348483300817</c:v>
                  </c:pt>
                  <c:pt idx="11">
                    <c:v>0.0393758804826721</c:v>
                  </c:pt>
                  <c:pt idx="12">
                    <c:v>0.0146253333024438</c:v>
                  </c:pt>
                  <c:pt idx="13">
                    <c:v>0.15862952326932</c:v>
                  </c:pt>
                  <c:pt idx="14">
                    <c:v>0.412128797121843</c:v>
                  </c:pt>
                  <c:pt idx="15">
                    <c:v>0.0656513399975749</c:v>
                  </c:pt>
                  <c:pt idx="16">
                    <c:v>0.153308949546769</c:v>
                  </c:pt>
                  <c:pt idx="17">
                    <c:v>0.927894706445102</c:v>
                  </c:pt>
                </c:numCache>
              </c:numRef>
            </c:minus>
          </c:errBars>
          <c:cat>
            <c:strRef>
              <c:f>Feuil3!$A$26:$A$41</c:f>
              <c:strCache>
                <c:ptCount val="16"/>
                <c:pt idx="0">
                  <c:v>tnt-2</c:v>
                </c:pt>
                <c:pt idx="1">
                  <c:v>mlc-3</c:v>
                </c:pt>
                <c:pt idx="2">
                  <c:v>unc-54</c:v>
                </c:pt>
                <c:pt idx="3">
                  <c:v>mlc-1</c:v>
                </c:pt>
                <c:pt idx="4">
                  <c:v>mlc-2</c:v>
                </c:pt>
                <c:pt idx="5">
                  <c:v>unc-27</c:v>
                </c:pt>
                <c:pt idx="6">
                  <c:v>unc-15</c:v>
                </c:pt>
                <c:pt idx="7">
                  <c:v>M02D8.1</c:v>
                </c:pt>
                <c:pt idx="8">
                  <c:v>csq-1</c:v>
                </c:pt>
                <c:pt idx="9">
                  <c:v>mup-2</c:v>
                </c:pt>
                <c:pt idx="10">
                  <c:v>unc-87</c:v>
                </c:pt>
                <c:pt idx="11">
                  <c:v>twk-18</c:v>
                </c:pt>
                <c:pt idx="12">
                  <c:v>alp-1</c:v>
                </c:pt>
                <c:pt idx="13">
                  <c:v>mig-17</c:v>
                </c:pt>
                <c:pt idx="14">
                  <c:v>F21H7.3</c:v>
                </c:pt>
                <c:pt idx="15">
                  <c:v>dys-1</c:v>
                </c:pt>
              </c:strCache>
            </c:strRef>
          </c:cat>
          <c:val>
            <c:numRef>
              <c:f>Feuil3!$C$26:$C$41</c:f>
              <c:numCache>
                <c:formatCode>General</c:formatCode>
                <c:ptCount val="16"/>
                <c:pt idx="0">
                  <c:v>0.0264172176559032</c:v>
                </c:pt>
                <c:pt idx="1">
                  <c:v>0.0390216319642067</c:v>
                </c:pt>
                <c:pt idx="2">
                  <c:v>0.0284854423942373</c:v>
                </c:pt>
                <c:pt idx="3">
                  <c:v>0.0556536227456566</c:v>
                </c:pt>
                <c:pt idx="4">
                  <c:v>0.0625646085724227</c:v>
                </c:pt>
                <c:pt idx="5">
                  <c:v>0.060446587773931</c:v>
                </c:pt>
                <c:pt idx="6">
                  <c:v>0.0702020147551823</c:v>
                </c:pt>
                <c:pt idx="7">
                  <c:v>0.0785158256957674</c:v>
                </c:pt>
                <c:pt idx="8">
                  <c:v>0.0742242860267812</c:v>
                </c:pt>
                <c:pt idx="9">
                  <c:v>0.0693225350738385</c:v>
                </c:pt>
                <c:pt idx="10">
                  <c:v>0.0992566035746296</c:v>
                </c:pt>
                <c:pt idx="11">
                  <c:v>0.169000407348414</c:v>
                </c:pt>
                <c:pt idx="12">
                  <c:v>0.167000502564236</c:v>
                </c:pt>
                <c:pt idx="13">
                  <c:v>1.01524011480958</c:v>
                </c:pt>
                <c:pt idx="14">
                  <c:v>1.260030671564606</c:v>
                </c:pt>
                <c:pt idx="15">
                  <c:v>0.6108027193912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9990376"/>
        <c:axId val="-2066248328"/>
      </c:barChart>
      <c:catAx>
        <c:axId val="-20699903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3420000"/>
          <a:lstStyle/>
          <a:p>
            <a:pPr>
              <a:defRPr sz="600" i="1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066248328"/>
        <c:crosses val="autoZero"/>
        <c:auto val="1"/>
        <c:lblAlgn val="ctr"/>
        <c:lblOffset val="100"/>
        <c:noMultiLvlLbl val="0"/>
      </c:catAx>
      <c:valAx>
        <c:axId val="-2066248328"/>
        <c:scaling>
          <c:orientation val="minMax"/>
          <c:max val="1.79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06999037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21910281767024"/>
          <c:y val="0.343474637536745"/>
          <c:w val="0.076063814890015"/>
          <c:h val="0.118000687962984"/>
        </c:manualLayout>
      </c:layout>
      <c:overlay val="0"/>
      <c:txPr>
        <a:bodyPr/>
        <a:lstStyle/>
        <a:p>
          <a:pPr>
            <a:defRPr sz="600">
              <a:latin typeface="Arial" charset="0"/>
              <a:ea typeface="Arial" charset="0"/>
              <a:cs typeface="Arial" charset="0"/>
            </a:defRPr>
          </a:pPr>
          <a:endParaRPr lang="fr-FR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070F67-5473-AF48-B05D-127E3B9C509F}" type="datetimeFigureOut">
              <a:rPr lang="fr-FR" smtClean="0"/>
              <a:t>13/10/17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7C9A88-05E9-8845-93C0-D199129BB6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252909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7B5A8-BF67-704C-AD71-2B0235AC2383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AF027-CC21-5144-BC0B-1EBF557219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23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03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419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012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712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29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699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448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43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193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230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839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407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ZoneTexte 75"/>
          <p:cNvSpPr txBox="1"/>
          <p:nvPr/>
        </p:nvSpPr>
        <p:spPr>
          <a:xfrm>
            <a:off x="46359" y="5805606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							      		</a:t>
            </a:r>
            <a:endParaRPr lang="en-US" dirty="0"/>
          </a:p>
        </p:txBody>
      </p:sp>
      <p:graphicFrame>
        <p:nvGraphicFramePr>
          <p:cNvPr id="97" name="Tableau 9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5013472"/>
              </p:ext>
            </p:extLst>
          </p:nvPr>
        </p:nvGraphicFramePr>
        <p:xfrm>
          <a:off x="198759" y="2796854"/>
          <a:ext cx="3035089" cy="2936245"/>
        </p:xfrm>
        <a:graphic>
          <a:graphicData uri="http://schemas.openxmlformats.org/drawingml/2006/table">
            <a:tbl>
              <a:tblPr/>
              <a:tblGrid>
                <a:gridCol w="446781"/>
                <a:gridCol w="628258"/>
                <a:gridCol w="411748"/>
                <a:gridCol w="520003"/>
                <a:gridCol w="643644"/>
                <a:gridCol w="384655"/>
              </a:tblGrid>
              <a:tr h="11761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1" u="none" strike="noStrike" noProof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. </a:t>
                      </a:r>
                      <a:r>
                        <a:rPr lang="en-US" sz="600" b="0" i="1" u="none" strike="noStrike" noProof="0" err="1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legans</a:t>
                      </a:r>
                      <a:r>
                        <a:rPr lang="en-US" sz="600" b="0" i="1" u="none" strike="noStrike" noProof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en-US" sz="600" b="0" i="1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4F81BD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noProof="0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Homologs in mammals</a:t>
                      </a:r>
                      <a:endParaRPr lang="en-US" sz="6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noProof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old changes</a:t>
                      </a:r>
                      <a:endParaRPr lang="en-US" sz="6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1" u="none" strike="noStrike" noProof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. </a:t>
                      </a:r>
                      <a:r>
                        <a:rPr lang="en-US" sz="600" b="0" i="1" u="none" strike="noStrike" noProof="0" err="1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legans</a:t>
                      </a:r>
                      <a:r>
                        <a:rPr lang="en-US" sz="600" b="0" i="1" u="none" strike="noStrike" noProof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en-US" sz="600" b="0" i="1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4F81BD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noProof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Homologs in mammals</a:t>
                      </a:r>
                      <a:endParaRPr lang="en-US" sz="6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noProof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old changes</a:t>
                      </a:r>
                      <a:endParaRPr lang="en-US" sz="6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</a:tr>
              <a:tr h="11761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noProof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enes</a:t>
                      </a:r>
                      <a:endParaRPr lang="en-US" sz="6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noProof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enes</a:t>
                      </a:r>
                      <a:endParaRPr lang="en-US" sz="6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7512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nt-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roponin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2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unc-54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 err="1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yosin</a:t>
                      </a:r>
                      <a:r>
                        <a:rPr lang="fr-FR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heavy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fr-FR" sz="600" b="0" i="0" u="none" strike="noStrike" err="1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hains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5,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  <a:tr h="197512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lc-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yosin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regulatory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light </a:t>
                      </a:r>
                      <a:r>
                        <a:rPr lang="fr-FR" sz="600" b="0" i="0" u="none" strike="noStrike" err="1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hains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14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lp-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LIM 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omain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fr-FR" sz="600" b="0" i="0" u="none" strike="noStrike" err="1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roteins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5,5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197512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up-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roponin 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10,9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snl-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</a:t>
                      </a:r>
                      <a:r>
                        <a:rPr lang="fr-FR" sz="600" b="0" i="0" u="none" strike="noStrike" err="1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lsolin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related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rotein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5,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  <a:tr h="142681">
                <a:tc>
                  <a:txBody>
                    <a:bodyPr/>
                    <a:lstStyle/>
                    <a:p>
                      <a:pPr algn="ctr" fontAlgn="ctr"/>
                      <a:r>
                        <a:rPr lang="hu-HU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zig-1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itin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9,6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lev-1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ropomyosin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5,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197512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lc-3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yosin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light </a:t>
                      </a:r>
                      <a:r>
                        <a:rPr lang="fr-FR" sz="600" b="0" i="0" u="none" strike="noStrike" err="1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hains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8,5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at-10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roponin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C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5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  <a:tr h="197512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unc-27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roponin I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8,3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K09A9.6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sph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(aspartate beta-hydroxylase)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4,3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197512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unc-15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aramyosin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7,3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zyx-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LIM 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omain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fr-FR" sz="600" b="0" i="0" u="none" strike="noStrike" err="1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roteins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4,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  <a:tr h="142681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unc-87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alponin like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7,3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hsp-25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H</a:t>
                      </a:r>
                      <a:r>
                        <a:rPr lang="fr-FR" sz="600" b="0" i="0" u="none" strike="noStrike" err="1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at</a:t>
                      </a:r>
                      <a:r>
                        <a:rPr lang="fr-FR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shock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rotein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3,5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10430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ni-3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roponin I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7,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unc-44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nkyrin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3,4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  <a:tr h="197512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wk-1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otassium 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hannels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7,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u-HU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yo-3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yosin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heavy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fr-FR" sz="600" b="0" i="0" u="none" strike="noStrike" err="1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hains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3,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10430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sq-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alsequestrin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7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ln-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alin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2,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  <a:tr h="197512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lc-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yosin</a:t>
                      </a:r>
                      <a:r>
                        <a:rPr lang="fr-F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fr-FR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regulatory</a:t>
                      </a:r>
                      <a:r>
                        <a:rPr lang="fr-F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light </a:t>
                      </a:r>
                      <a:r>
                        <a:rPr lang="fr-FR" sz="6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hains</a:t>
                      </a:r>
                      <a:r>
                        <a:rPr lang="fr-F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6,6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nmt-3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icotinamide N 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ethyl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ransferase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2,7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197512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qp-7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 err="1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quaglyceroporins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6,5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pna-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opine 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omain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 </a:t>
                      </a:r>
                      <a:r>
                        <a:rPr lang="fr-FR" sz="600" b="0" i="0" u="none" strike="noStrike" err="1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roteins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2,6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  <a:tr h="197512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ni-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roponin I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6,5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1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fhd-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F-hand 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omain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fr-FR" sz="600" b="0" i="0" u="none" strike="noStrike" err="1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ontaining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fr-FR" sz="600" b="0" i="0" u="none" strike="noStrike" err="1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roteins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  <p:grpSp>
        <p:nvGrpSpPr>
          <p:cNvPr id="113" name="Grouper 112"/>
          <p:cNvGrpSpPr/>
          <p:nvPr/>
        </p:nvGrpSpPr>
        <p:grpSpPr>
          <a:xfrm>
            <a:off x="3226161" y="3183450"/>
            <a:ext cx="4320326" cy="2734691"/>
            <a:chOff x="92670" y="6409309"/>
            <a:chExt cx="5920494" cy="2734691"/>
          </a:xfrm>
        </p:grpSpPr>
        <p:graphicFrame>
          <p:nvGraphicFramePr>
            <p:cNvPr id="137" name="Graphique 13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30873231"/>
                </p:ext>
              </p:extLst>
            </p:nvPr>
          </p:nvGraphicFramePr>
          <p:xfrm>
            <a:off x="193143" y="6409309"/>
            <a:ext cx="5820021" cy="273469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139" name="Grouper 138"/>
            <p:cNvGrpSpPr/>
            <p:nvPr/>
          </p:nvGrpSpPr>
          <p:grpSpPr>
            <a:xfrm>
              <a:off x="92670" y="6473953"/>
              <a:ext cx="4355180" cy="1760961"/>
              <a:chOff x="92670" y="6473953"/>
              <a:chExt cx="4355180" cy="1760961"/>
            </a:xfrm>
          </p:grpSpPr>
          <p:grpSp>
            <p:nvGrpSpPr>
              <p:cNvPr id="140" name="Grouper 139"/>
              <p:cNvGrpSpPr/>
              <p:nvPr/>
            </p:nvGrpSpPr>
            <p:grpSpPr>
              <a:xfrm>
                <a:off x="92670" y="6795481"/>
                <a:ext cx="3638564" cy="1439433"/>
                <a:chOff x="3179424" y="1343748"/>
                <a:chExt cx="3893858" cy="1540432"/>
              </a:xfrm>
            </p:grpSpPr>
            <p:grpSp>
              <p:nvGrpSpPr>
                <p:cNvPr id="147" name="Grouper 146"/>
                <p:cNvGrpSpPr>
                  <a:grpSpLocks noChangeAspect="1"/>
                </p:cNvGrpSpPr>
                <p:nvPr/>
              </p:nvGrpSpPr>
              <p:grpSpPr>
                <a:xfrm>
                  <a:off x="3640539" y="1343748"/>
                  <a:ext cx="3432743" cy="198803"/>
                  <a:chOff x="1095674" y="481949"/>
                  <a:chExt cx="2461470" cy="210840"/>
                </a:xfrm>
              </p:grpSpPr>
              <p:sp>
                <p:nvSpPr>
                  <p:cNvPr id="162" name="ZoneTexte 161"/>
                  <p:cNvSpPr txBox="1"/>
                  <p:nvPr/>
                </p:nvSpPr>
                <p:spPr>
                  <a:xfrm>
                    <a:off x="1095674" y="483200"/>
                    <a:ext cx="290278" cy="2095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charset="0"/>
                        <a:ea typeface="Arial" charset="0"/>
                        <a:cs typeface="Arial" charset="0"/>
                      </a:rPr>
                      <a:t>***</a:t>
                    </a:r>
                    <a:endParaRPr lang="en-US" sz="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63" name="ZoneTexte 162"/>
                  <p:cNvSpPr txBox="1"/>
                  <p:nvPr/>
                </p:nvSpPr>
                <p:spPr>
                  <a:xfrm>
                    <a:off x="1275488" y="483200"/>
                    <a:ext cx="290278" cy="2095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smtClean="0">
                        <a:latin typeface="Arial" charset="0"/>
                        <a:ea typeface="Arial" charset="0"/>
                        <a:cs typeface="Arial" charset="0"/>
                      </a:rPr>
                      <a:t>***</a:t>
                    </a:r>
                    <a:endParaRPr lang="en-US" sz="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64" name="ZoneTexte 163"/>
                  <p:cNvSpPr txBox="1"/>
                  <p:nvPr/>
                </p:nvSpPr>
                <p:spPr>
                  <a:xfrm>
                    <a:off x="1460091" y="483200"/>
                    <a:ext cx="290278" cy="2095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charset="0"/>
                        <a:ea typeface="Arial" charset="0"/>
                        <a:cs typeface="Arial" charset="0"/>
                      </a:rPr>
                      <a:t>***</a:t>
                    </a:r>
                    <a:endParaRPr lang="en-US" sz="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65" name="ZoneTexte 164"/>
                  <p:cNvSpPr txBox="1"/>
                  <p:nvPr/>
                </p:nvSpPr>
                <p:spPr>
                  <a:xfrm>
                    <a:off x="1639902" y="483200"/>
                    <a:ext cx="290278" cy="2095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charset="0"/>
                        <a:ea typeface="Arial" charset="0"/>
                        <a:cs typeface="Arial" charset="0"/>
                      </a:rPr>
                      <a:t>***</a:t>
                    </a:r>
                    <a:endParaRPr lang="en-US" sz="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66" name="ZoneTexte 165"/>
                  <p:cNvSpPr txBox="1"/>
                  <p:nvPr/>
                </p:nvSpPr>
                <p:spPr>
                  <a:xfrm>
                    <a:off x="1828205" y="483200"/>
                    <a:ext cx="290278" cy="2095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charset="0"/>
                        <a:ea typeface="Arial" charset="0"/>
                        <a:cs typeface="Arial" charset="0"/>
                      </a:rPr>
                      <a:t>***</a:t>
                    </a:r>
                    <a:endParaRPr lang="en-US" sz="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67" name="ZoneTexte 166"/>
                  <p:cNvSpPr txBox="1"/>
                  <p:nvPr/>
                </p:nvSpPr>
                <p:spPr>
                  <a:xfrm>
                    <a:off x="2006475" y="483200"/>
                    <a:ext cx="290278" cy="2095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charset="0"/>
                        <a:ea typeface="Arial" charset="0"/>
                        <a:cs typeface="Arial" charset="0"/>
                      </a:rPr>
                      <a:t>***</a:t>
                    </a:r>
                    <a:endParaRPr lang="en-US" sz="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68" name="ZoneTexte 167"/>
                  <p:cNvSpPr txBox="1"/>
                  <p:nvPr/>
                </p:nvSpPr>
                <p:spPr>
                  <a:xfrm>
                    <a:off x="2183225" y="481949"/>
                    <a:ext cx="290278" cy="2095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charset="0"/>
                        <a:ea typeface="Arial" charset="0"/>
                        <a:cs typeface="Arial" charset="0"/>
                      </a:rPr>
                      <a:t>***</a:t>
                    </a:r>
                    <a:endParaRPr lang="en-US" sz="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69" name="ZoneTexte 168"/>
                  <p:cNvSpPr txBox="1"/>
                  <p:nvPr/>
                </p:nvSpPr>
                <p:spPr>
                  <a:xfrm>
                    <a:off x="2370593" y="481949"/>
                    <a:ext cx="290278" cy="2095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charset="0"/>
                        <a:ea typeface="Arial" charset="0"/>
                        <a:cs typeface="Arial" charset="0"/>
                      </a:rPr>
                      <a:t>***</a:t>
                    </a:r>
                    <a:endParaRPr lang="en-US" sz="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70" name="ZoneTexte 169"/>
                  <p:cNvSpPr txBox="1"/>
                  <p:nvPr/>
                </p:nvSpPr>
                <p:spPr>
                  <a:xfrm>
                    <a:off x="2554994" y="483200"/>
                    <a:ext cx="290278" cy="2095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charset="0"/>
                        <a:ea typeface="Arial" charset="0"/>
                        <a:cs typeface="Arial" charset="0"/>
                      </a:rPr>
                      <a:t>***</a:t>
                    </a:r>
                    <a:endParaRPr lang="en-US" sz="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71" name="ZoneTexte 170"/>
                  <p:cNvSpPr txBox="1"/>
                  <p:nvPr/>
                </p:nvSpPr>
                <p:spPr>
                  <a:xfrm>
                    <a:off x="2733271" y="483200"/>
                    <a:ext cx="290278" cy="2095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charset="0"/>
                        <a:ea typeface="Arial" charset="0"/>
                        <a:cs typeface="Arial" charset="0"/>
                      </a:rPr>
                      <a:t>***</a:t>
                    </a:r>
                    <a:endParaRPr lang="en-US" sz="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72" name="ZoneTexte 171"/>
                  <p:cNvSpPr txBox="1"/>
                  <p:nvPr/>
                </p:nvSpPr>
                <p:spPr>
                  <a:xfrm>
                    <a:off x="2909393" y="481949"/>
                    <a:ext cx="290278" cy="2095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charset="0"/>
                        <a:ea typeface="Arial" charset="0"/>
                        <a:cs typeface="Arial" charset="0"/>
                      </a:rPr>
                      <a:t>***</a:t>
                    </a:r>
                    <a:endParaRPr lang="en-US" sz="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73" name="ZoneTexte 172"/>
                  <p:cNvSpPr txBox="1"/>
                  <p:nvPr/>
                </p:nvSpPr>
                <p:spPr>
                  <a:xfrm>
                    <a:off x="3106393" y="481949"/>
                    <a:ext cx="258249" cy="2095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charset="0"/>
                        <a:ea typeface="Arial" charset="0"/>
                        <a:cs typeface="Arial" charset="0"/>
                      </a:rPr>
                      <a:t>**</a:t>
                    </a:r>
                    <a:endParaRPr lang="en-US" sz="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74" name="ZoneTexte 173"/>
                  <p:cNvSpPr txBox="1"/>
                  <p:nvPr/>
                </p:nvSpPr>
                <p:spPr>
                  <a:xfrm>
                    <a:off x="3266866" y="481949"/>
                    <a:ext cx="290278" cy="2095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charset="0"/>
                        <a:ea typeface="Arial" charset="0"/>
                        <a:cs typeface="Arial" charset="0"/>
                      </a:rPr>
                      <a:t>***</a:t>
                    </a:r>
                    <a:endParaRPr lang="en-US" sz="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sp>
              <p:nvSpPr>
                <p:cNvPr id="148" name="ZoneTexte 147"/>
                <p:cNvSpPr txBox="1"/>
                <p:nvPr/>
              </p:nvSpPr>
              <p:spPr>
                <a:xfrm rot="16200000">
                  <a:off x="2575576" y="2082709"/>
                  <a:ext cx="1405319" cy="19762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b="1" dirty="0">
                      <a:latin typeface="Arial" charset="0"/>
                      <a:ea typeface="Arial" charset="0"/>
                      <a:cs typeface="Arial" charset="0"/>
                    </a:rPr>
                    <a:t>R</a:t>
                  </a:r>
                  <a:r>
                    <a:rPr lang="fr-FR" sz="600" b="1" dirty="0" smtClean="0">
                      <a:latin typeface="Arial" charset="0"/>
                      <a:ea typeface="Arial" charset="0"/>
                      <a:cs typeface="Arial" charset="0"/>
                    </a:rPr>
                    <a:t>elative </a:t>
                  </a:r>
                  <a:r>
                    <a:rPr lang="fr-FR" sz="600" b="1" dirty="0" err="1">
                      <a:latin typeface="Arial" charset="0"/>
                      <a:ea typeface="Arial" charset="0"/>
                      <a:cs typeface="Arial" charset="0"/>
                    </a:rPr>
                    <a:t>quantity</a:t>
                  </a:r>
                  <a:r>
                    <a:rPr lang="fr-FR" sz="600" b="1" dirty="0">
                      <a:latin typeface="Arial" charset="0"/>
                      <a:ea typeface="Arial" charset="0"/>
                      <a:cs typeface="Arial" charset="0"/>
                    </a:rPr>
                    <a:t> of </a:t>
                  </a:r>
                  <a:r>
                    <a:rPr lang="fr-FR" sz="600" b="1" dirty="0" err="1">
                      <a:latin typeface="Arial" charset="0"/>
                      <a:ea typeface="Arial" charset="0"/>
                      <a:cs typeface="Arial" charset="0"/>
                    </a:rPr>
                    <a:t>transcripts</a:t>
                  </a:r>
                  <a:endParaRPr lang="fr-FR" sz="6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149" name="Connecteur droit 148"/>
                <p:cNvCxnSpPr/>
                <p:nvPr/>
              </p:nvCxnSpPr>
              <p:spPr>
                <a:xfrm flipV="1">
                  <a:off x="3785525" y="1468465"/>
                  <a:ext cx="108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0" name="Connecteur droit 149"/>
                <p:cNvCxnSpPr/>
                <p:nvPr/>
              </p:nvCxnSpPr>
              <p:spPr>
                <a:xfrm flipV="1">
                  <a:off x="4038431" y="1468465"/>
                  <a:ext cx="108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1" name="Connecteur droit 150"/>
                <p:cNvCxnSpPr/>
                <p:nvPr/>
              </p:nvCxnSpPr>
              <p:spPr>
                <a:xfrm flipV="1">
                  <a:off x="4297199" y="1468465"/>
                  <a:ext cx="108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2" name="Connecteur droit 151"/>
                <p:cNvCxnSpPr/>
                <p:nvPr/>
              </p:nvCxnSpPr>
              <p:spPr>
                <a:xfrm flipV="1">
                  <a:off x="4549343" y="1468465"/>
                  <a:ext cx="108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3" name="Connecteur droit 152"/>
                <p:cNvCxnSpPr/>
                <p:nvPr/>
              </p:nvCxnSpPr>
              <p:spPr>
                <a:xfrm flipV="1">
                  <a:off x="4803564" y="1468464"/>
                  <a:ext cx="108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4" name="Connecteur droit 153"/>
                <p:cNvCxnSpPr/>
                <p:nvPr/>
              </p:nvCxnSpPr>
              <p:spPr>
                <a:xfrm flipV="1">
                  <a:off x="5054239" y="1468464"/>
                  <a:ext cx="108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5" name="Connecteur droit 154"/>
                <p:cNvCxnSpPr/>
                <p:nvPr/>
              </p:nvCxnSpPr>
              <p:spPr>
                <a:xfrm flipV="1">
                  <a:off x="5309933" y="1468464"/>
                  <a:ext cx="108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6" name="Connecteur droit 155"/>
                <p:cNvCxnSpPr/>
                <p:nvPr/>
              </p:nvCxnSpPr>
              <p:spPr>
                <a:xfrm flipV="1">
                  <a:off x="5568701" y="1468464"/>
                  <a:ext cx="108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7" name="Connecteur droit 156"/>
                <p:cNvCxnSpPr/>
                <p:nvPr/>
              </p:nvCxnSpPr>
              <p:spPr>
                <a:xfrm flipV="1">
                  <a:off x="5820845" y="1468464"/>
                  <a:ext cx="108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8" name="Connecteur droit 157"/>
                <p:cNvCxnSpPr/>
                <p:nvPr/>
              </p:nvCxnSpPr>
              <p:spPr>
                <a:xfrm flipV="1">
                  <a:off x="6075066" y="1468463"/>
                  <a:ext cx="108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9" name="Connecteur droit 158"/>
                <p:cNvCxnSpPr/>
                <p:nvPr/>
              </p:nvCxnSpPr>
              <p:spPr>
                <a:xfrm flipV="1">
                  <a:off x="6325741" y="1468463"/>
                  <a:ext cx="108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0" name="Connecteur droit 159"/>
                <p:cNvCxnSpPr/>
                <p:nvPr/>
              </p:nvCxnSpPr>
              <p:spPr>
                <a:xfrm flipV="1">
                  <a:off x="6572241" y="1468462"/>
                  <a:ext cx="108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1" name="Connecteur droit 160"/>
                <p:cNvCxnSpPr/>
                <p:nvPr/>
              </p:nvCxnSpPr>
              <p:spPr>
                <a:xfrm flipV="1">
                  <a:off x="6822916" y="1468462"/>
                  <a:ext cx="108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41" name="Connecteur droit 140"/>
              <p:cNvCxnSpPr/>
              <p:nvPr/>
            </p:nvCxnSpPr>
            <p:spPr>
              <a:xfrm flipV="1">
                <a:off x="3729358" y="6912648"/>
                <a:ext cx="100919" cy="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Connecteur droit 141"/>
              <p:cNvCxnSpPr/>
              <p:nvPr/>
            </p:nvCxnSpPr>
            <p:spPr>
              <a:xfrm flipV="1">
                <a:off x="4219443" y="7121962"/>
                <a:ext cx="100919" cy="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Connecteur droit 142"/>
              <p:cNvCxnSpPr/>
              <p:nvPr/>
            </p:nvCxnSpPr>
            <p:spPr>
              <a:xfrm flipV="1">
                <a:off x="3965866" y="6614175"/>
                <a:ext cx="100919" cy="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4" name="ZoneTexte 143"/>
              <p:cNvSpPr txBox="1"/>
              <p:nvPr/>
            </p:nvSpPr>
            <p:spPr>
              <a:xfrm>
                <a:off x="3597307" y="6773824"/>
                <a:ext cx="365097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smtClean="0">
                    <a:latin typeface="Arial" charset="0"/>
                    <a:ea typeface="Arial" charset="0"/>
                    <a:cs typeface="Arial" charset="0"/>
                  </a:rPr>
                  <a:t>ns</a:t>
                </a:r>
                <a:endParaRPr lang="en-US" sz="60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5" name="ZoneTexte 144"/>
              <p:cNvSpPr txBox="1"/>
              <p:nvPr/>
            </p:nvSpPr>
            <p:spPr>
              <a:xfrm>
                <a:off x="3834872" y="6473953"/>
                <a:ext cx="365097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smtClean="0">
                    <a:latin typeface="Arial" charset="0"/>
                    <a:ea typeface="Arial" charset="0"/>
                    <a:cs typeface="Arial" charset="0"/>
                  </a:rPr>
                  <a:t>ns</a:t>
                </a:r>
                <a:endParaRPr lang="en-US" sz="60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6" name="ZoneTexte 145"/>
              <p:cNvSpPr txBox="1"/>
              <p:nvPr/>
            </p:nvSpPr>
            <p:spPr>
              <a:xfrm>
                <a:off x="4082753" y="6985452"/>
                <a:ext cx="365097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ns</a:t>
                </a:r>
                <a:endParaRPr lang="en-US" sz="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sp>
        <p:nvSpPr>
          <p:cNvPr id="175" name="ZoneTexte 174"/>
          <p:cNvSpPr txBox="1"/>
          <p:nvPr/>
        </p:nvSpPr>
        <p:spPr>
          <a:xfrm>
            <a:off x="46359" y="2454213"/>
            <a:ext cx="68519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 		    		</a:t>
            </a:r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       			   b			  		</a:t>
            </a:r>
            <a:endParaRPr 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6" name="ZoneTexte 175"/>
          <p:cNvSpPr txBox="1"/>
          <p:nvPr/>
        </p:nvSpPr>
        <p:spPr>
          <a:xfrm>
            <a:off x="19243" y="6493293"/>
            <a:ext cx="68580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S4 </a:t>
            </a:r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Down-regulation of muscle specific transcripts in wild-type worms with age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749962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Bureau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Bureau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Bureau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1812</TotalTime>
  <Words>292</Words>
  <Application>Microsoft Macintosh PowerPoint</Application>
  <PresentationFormat>Présentation à l'écran (4:3)</PresentationFormat>
  <Paragraphs>11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eline</dc:creator>
  <cp:lastModifiedBy>Florence Solari</cp:lastModifiedBy>
  <cp:revision>1214</cp:revision>
  <cp:lastPrinted>2017-08-11T12:03:05Z</cp:lastPrinted>
  <dcterms:created xsi:type="dcterms:W3CDTF">2015-07-15T09:53:29Z</dcterms:created>
  <dcterms:modified xsi:type="dcterms:W3CDTF">2017-10-13T09:13:13Z</dcterms:modified>
</cp:coreProperties>
</file>